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95" r:id="rId2"/>
    <p:sldId id="300" r:id="rId3"/>
    <p:sldId id="301" r:id="rId4"/>
    <p:sldId id="296" r:id="rId5"/>
    <p:sldId id="303" r:id="rId6"/>
    <p:sldId id="305" r:id="rId7"/>
    <p:sldId id="297" r:id="rId8"/>
  </p:sldIdLst>
  <p:sldSz cx="6858000" cy="9144000" type="screen4x3"/>
  <p:notesSz cx="9869488" cy="6735763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99"/>
    <a:srgbClr val="99FF99"/>
    <a:srgbClr val="66FF66"/>
    <a:srgbClr val="99FF66"/>
    <a:srgbClr val="FFCCFF"/>
    <a:srgbClr val="FFFFCC"/>
    <a:srgbClr val="FFFF99"/>
    <a:srgbClr val="FFFF66"/>
    <a:srgbClr val="0000FF"/>
    <a:srgbClr val="6819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33" autoAdjust="0"/>
    <p:restoredTop sz="98587" autoAdjust="0"/>
  </p:normalViewPr>
  <p:slideViewPr>
    <p:cSldViewPr snapToGrid="0" snapToObjects="1" showGuides="1">
      <p:cViewPr>
        <p:scale>
          <a:sx n="142" d="100"/>
          <a:sy n="142" d="100"/>
        </p:scale>
        <p:origin x="-1860" y="72"/>
      </p:cViewPr>
      <p:guideLst>
        <p:guide orient="horz" pos="3404"/>
        <p:guide pos="226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276778" cy="336788"/>
          </a:xfrm>
          <a:prstGeom prst="rect">
            <a:avLst/>
          </a:prstGeom>
        </p:spPr>
        <p:txBody>
          <a:bodyPr vert="horz" lIns="91449" tIns="45725" rIns="91449" bIns="4572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90426" y="1"/>
            <a:ext cx="4276778" cy="336788"/>
          </a:xfrm>
          <a:prstGeom prst="rect">
            <a:avLst/>
          </a:prstGeom>
        </p:spPr>
        <p:txBody>
          <a:bodyPr vert="horz" lIns="91449" tIns="45725" rIns="91449" bIns="45725" rtlCol="0"/>
          <a:lstStyle>
            <a:lvl1pPr algn="r">
              <a:defRPr sz="1200"/>
            </a:lvl1pPr>
          </a:lstStyle>
          <a:p>
            <a:fld id="{11180920-75C6-4BE0-A04E-5B538A00CAA6}" type="datetimeFigureOut">
              <a:rPr kumimoji="1" lang="ja-JP" altLang="en-US" smtClean="0"/>
              <a:pPr/>
              <a:t>2015/5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397807"/>
            <a:ext cx="4276778" cy="336788"/>
          </a:xfrm>
          <a:prstGeom prst="rect">
            <a:avLst/>
          </a:prstGeom>
        </p:spPr>
        <p:txBody>
          <a:bodyPr vert="horz" lIns="91449" tIns="45725" rIns="91449" bIns="4572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90426" y="6397807"/>
            <a:ext cx="4276778" cy="336788"/>
          </a:xfrm>
          <a:prstGeom prst="rect">
            <a:avLst/>
          </a:prstGeom>
        </p:spPr>
        <p:txBody>
          <a:bodyPr vert="horz" lIns="91449" tIns="45725" rIns="91449" bIns="45725" rtlCol="0" anchor="b"/>
          <a:lstStyle>
            <a:lvl1pPr algn="r">
              <a:defRPr sz="1200"/>
            </a:lvl1pPr>
          </a:lstStyle>
          <a:p>
            <a:fld id="{C836C001-8CAD-4491-A0F2-8ACB064B3D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1138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6725" cy="336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91175" y="0"/>
            <a:ext cx="4276725" cy="336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985B0A-6071-48D5-BC96-4037C563E518}" type="datetimeFigureOut">
              <a:rPr kumimoji="1" lang="ja-JP" altLang="en-US" smtClean="0"/>
              <a:t>2015/5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987800" y="504825"/>
            <a:ext cx="1893888" cy="25257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7425" y="3198813"/>
            <a:ext cx="7894638" cy="30321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397625"/>
            <a:ext cx="4276725" cy="336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91175" y="6397625"/>
            <a:ext cx="4276725" cy="336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2DFED6-82A9-48D8-B072-AB7DFA1300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30875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2DFED6-82A9-48D8-B072-AB7DFA130049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8970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2DFED6-82A9-48D8-B072-AB7DFA130049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144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 smtClean="0"/>
              <a:t>マスタ タイトルの書式設定</a:t>
            </a:r>
            <a:endParaRPr lang="ja-JP" altLang="en-US" dirty="0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 smtClean="0"/>
              <a:t>マスタ テキストの書式設定</a:t>
            </a:r>
          </a:p>
          <a:p>
            <a:pPr lvl="1"/>
            <a:r>
              <a:rPr lang="ja-JP" altLang="en-US" dirty="0" smtClean="0"/>
              <a:t>第 </a:t>
            </a:r>
            <a:r>
              <a:rPr lang="en-US" altLang="ja-JP" dirty="0" smtClean="0"/>
              <a:t>2 </a:t>
            </a:r>
            <a:r>
              <a:rPr lang="ja-JP" altLang="en-US" dirty="0" smtClean="0"/>
              <a:t>レベル</a:t>
            </a:r>
          </a:p>
          <a:p>
            <a:pPr lvl="2"/>
            <a:r>
              <a:rPr lang="ja-JP" altLang="en-US" dirty="0" smtClean="0"/>
              <a:t>第 </a:t>
            </a:r>
            <a:r>
              <a:rPr lang="en-US" altLang="ja-JP" dirty="0" smtClean="0"/>
              <a:t>3 </a:t>
            </a:r>
            <a:r>
              <a:rPr lang="ja-JP" altLang="en-US" dirty="0" smtClean="0"/>
              <a:t>レベル</a:t>
            </a:r>
          </a:p>
          <a:p>
            <a:pPr lvl="3"/>
            <a:r>
              <a:rPr lang="ja-JP" altLang="en-US" dirty="0" smtClean="0"/>
              <a:t>第 </a:t>
            </a:r>
            <a:r>
              <a:rPr lang="en-US" altLang="ja-JP" dirty="0" smtClean="0"/>
              <a:t>4 </a:t>
            </a:r>
            <a:r>
              <a:rPr lang="ja-JP" altLang="en-US" dirty="0" smtClean="0"/>
              <a:t>レベル</a:t>
            </a:r>
          </a:p>
          <a:p>
            <a:pPr lvl="4"/>
            <a:r>
              <a:rPr lang="ja-JP" altLang="en-US" dirty="0" smtClean="0"/>
              <a:t>第 </a:t>
            </a:r>
            <a:r>
              <a:rPr lang="en-US" altLang="ja-JP" dirty="0" smtClean="0"/>
              <a:t>5 </a:t>
            </a:r>
            <a:r>
              <a:rPr lang="ja-JP" altLang="en-US" dirty="0" smtClean="0"/>
              <a:t>レベル</a:t>
            </a:r>
            <a:endParaRPr lang="ja-JP" altLang="en-US" dirty="0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4E707E47-F94E-EC43-8CD7-B8A50359B76F}" type="datetimeFigureOut">
              <a:rPr lang="ja-JP" altLang="en-US" smtClean="0"/>
              <a:pPr/>
              <a:t>2015/5/24</a:t>
            </a:fld>
            <a:endParaRPr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endParaRPr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13542D98-7F5D-0040-95ED-3DF19C42DFCC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Arial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Arial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Arial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Arial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Arial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Arial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6563455"/>
              </p:ext>
            </p:extLst>
          </p:nvPr>
        </p:nvGraphicFramePr>
        <p:xfrm>
          <a:off x="203200" y="2041809"/>
          <a:ext cx="6197600" cy="47560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62667"/>
                <a:gridCol w="891822"/>
                <a:gridCol w="2167467"/>
                <a:gridCol w="1275644"/>
              </a:tblGrid>
              <a:tr h="229574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arget</a:t>
                      </a:r>
                      <a:r>
                        <a:rPr kumimoji="1" lang="ja-JP" altLang="en-US" sz="1050" dirty="0" smtClean="0">
                          <a:latin typeface="+mn-lt"/>
                          <a:cs typeface="Courier New" panose="02070309020205020404" pitchFamily="49" charset="0"/>
                        </a:rPr>
                        <a:t>　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ene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gRNA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Name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Target sequence</a:t>
                      </a:r>
                      <a:r>
                        <a:rPr kumimoji="1" lang="ja-JP" altLang="en-US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  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/  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PAM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*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Restriction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Enzyme 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57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i="1" dirty="0" smtClean="0">
                          <a:latin typeface="+mn-lt"/>
                          <a:cs typeface="Courier New" panose="02070309020205020404" pitchFamily="49" charset="0"/>
                        </a:rPr>
                        <a:t>Young</a:t>
                      </a:r>
                      <a:r>
                        <a:rPr kumimoji="1" lang="en-US" altLang="ja-JP" sz="1050" i="1" baseline="0" dirty="0" smtClean="0">
                          <a:latin typeface="+mn-lt"/>
                          <a:cs typeface="Courier New" panose="02070309020205020404" pitchFamily="49" charset="0"/>
                        </a:rPr>
                        <a:t> Seedling Albino </a:t>
                      </a:r>
                      <a:r>
                        <a:rPr kumimoji="1" lang="en-US" altLang="ja-JP" sz="1050" i="0" baseline="0" dirty="0" smtClean="0">
                          <a:latin typeface="+mn-lt"/>
                          <a:cs typeface="Courier New" panose="02070309020205020404" pitchFamily="49" charset="0"/>
                        </a:rPr>
                        <a:t>(YSA)</a:t>
                      </a:r>
                      <a:endParaRPr kumimoji="1" lang="ja-JP" altLang="en-US" sz="1050" i="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gYSA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CGCGCCACCTC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GGCCGAAG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 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CGG</a:t>
                      </a:r>
                      <a:endParaRPr kumimoji="1" lang="ja-JP" altLang="en-US" sz="1050" u="sng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Sfi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574">
                <a:tc row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i="1" u="none" strike="noStrike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Courier New" panose="02070309020205020404" pitchFamily="49" charset="0"/>
                        </a:rPr>
                        <a:t>Phytoene</a:t>
                      </a:r>
                      <a:r>
                        <a:rPr kumimoji="1" lang="en-US" altLang="ja-JP" sz="1050" i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Courier New" panose="02070309020205020404" pitchFamily="49" charset="0"/>
                        </a:rPr>
                        <a:t> </a:t>
                      </a:r>
                      <a:r>
                        <a:rPr kumimoji="1" lang="en-US" altLang="ja-JP" sz="1050" i="1" u="none" strike="noStrike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Courier New" panose="02070309020205020404" pitchFamily="49" charset="0"/>
                        </a:rPr>
                        <a:t>desaturase</a:t>
                      </a:r>
                      <a:r>
                        <a:rPr kumimoji="1" lang="en-US" altLang="ja-JP" sz="1050" i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Courier New" panose="02070309020205020404" pitchFamily="49" charset="0"/>
                        </a:rPr>
                        <a:t>  </a:t>
                      </a:r>
                      <a:r>
                        <a:rPr kumimoji="1" lang="en-US" altLang="ja-JP" sz="105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Courier New" panose="02070309020205020404" pitchFamily="49" charset="0"/>
                        </a:rPr>
                        <a:t>(PDS)</a:t>
                      </a:r>
                      <a:endParaRPr kumimoji="1" lang="ja-JP" altLang="en-US" sz="1050" i="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solidFill>
                            <a:schemeClr val="tx1"/>
                          </a:solidFill>
                          <a:latin typeface="+mn-lt"/>
                          <a:cs typeface="Courier New" panose="02070309020205020404" pitchFamily="49" charset="0"/>
                        </a:rPr>
                        <a:t>gPDS-1</a:t>
                      </a:r>
                      <a:r>
                        <a:rPr lang="en-US" altLang="ja-JP" sz="1050" dirty="0" smtClean="0"/>
                        <a:t>†</a:t>
                      </a:r>
                      <a:endParaRPr kumimoji="1" lang="ja-JP" altLang="en-US" sz="1050" dirty="0" smtClean="0">
                        <a:solidFill>
                          <a:srgbClr val="FF0000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CGTCCAACCCATTCCT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CTGC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 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AG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Pst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4310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solidFill>
                            <a:schemeClr val="tx1"/>
                          </a:solidFill>
                          <a:latin typeface="+mn-lt"/>
                          <a:cs typeface="Courier New" panose="02070309020205020404" pitchFamily="49" charset="0"/>
                        </a:rPr>
                        <a:t>gPDS-2</a:t>
                      </a:r>
                      <a:endParaRPr kumimoji="1" lang="ja-JP" altLang="en-US" sz="1050" dirty="0" smtClean="0">
                        <a:solidFill>
                          <a:schemeClr val="tx1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GCTTTAAACCGATTTCTTC /  AG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×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</a:t>
                      </a:r>
                      <a:r>
                        <a:rPr lang="en-US" altLang="ja-JP" sz="1050" dirty="0" smtClean="0"/>
                        <a:t>††</a:t>
                      </a:r>
                      <a:endParaRPr kumimoji="1" lang="ja-JP" altLang="en-US" sz="1050" dirty="0" smtClean="0">
                        <a:solidFill>
                          <a:srgbClr val="FF0000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4310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50" i="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solidFill>
                            <a:schemeClr val="tx1"/>
                          </a:solidFill>
                          <a:latin typeface="+mn-lt"/>
                          <a:cs typeface="Courier New" panose="02070309020205020404" pitchFamily="49" charset="0"/>
                        </a:rPr>
                        <a:t>gPDS-3</a:t>
                      </a:r>
                      <a:endParaRPr kumimoji="1" lang="ja-JP" altLang="en-US" sz="1050" dirty="0" smtClean="0">
                        <a:solidFill>
                          <a:schemeClr val="tx1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ACAGTTGTTTGATCAGCACA /  GG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solidFill>
                            <a:schemeClr val="tx1"/>
                          </a:solidFill>
                          <a:latin typeface="+mn-lt"/>
                          <a:cs typeface="Courier New" panose="02070309020205020404" pitchFamily="49" charset="0"/>
                        </a:rPr>
                        <a:t>×</a:t>
                      </a:r>
                      <a:r>
                        <a:rPr kumimoji="1" lang="ja-JP" altLang="en-US" sz="1050" baseline="0" dirty="0" smtClean="0">
                          <a:solidFill>
                            <a:schemeClr val="tx1"/>
                          </a:solidFill>
                          <a:latin typeface="+mn-lt"/>
                          <a:cs typeface="Courier New" panose="02070309020205020404" pitchFamily="49" charset="0"/>
                        </a:rPr>
                        <a:t> </a:t>
                      </a:r>
                      <a:r>
                        <a:rPr lang="en-US" altLang="ja-JP" sz="1050" dirty="0" smtClean="0"/>
                        <a:t>††</a:t>
                      </a:r>
                      <a:endParaRPr kumimoji="1" lang="ja-JP" altLang="en-US" sz="1050" dirty="0" smtClean="0">
                        <a:solidFill>
                          <a:schemeClr val="tx1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4310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50" i="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solidFill>
                            <a:schemeClr val="tx1"/>
                          </a:solidFill>
                          <a:latin typeface="+mn-lt"/>
                          <a:cs typeface="Courier New" panose="02070309020205020404" pitchFamily="49" charset="0"/>
                        </a:rPr>
                        <a:t>gPDS-4</a:t>
                      </a:r>
                      <a:endParaRPr kumimoji="1" lang="ja-JP" altLang="en-US" sz="1050" dirty="0" smtClean="0">
                        <a:solidFill>
                          <a:schemeClr val="tx1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AAGAAGGATGTAA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TACGTA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 AG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err="1" smtClean="0">
                          <a:solidFill>
                            <a:schemeClr val="tx1"/>
                          </a:solidFill>
                          <a:latin typeface="+mn-lt"/>
                          <a:cs typeface="Courier New" panose="02070309020205020404" pitchFamily="49" charset="0"/>
                        </a:rPr>
                        <a:t>SnaBI</a:t>
                      </a:r>
                      <a:endParaRPr kumimoji="1" lang="ja-JP" altLang="en-US" sz="1050" dirty="0" smtClean="0">
                        <a:solidFill>
                          <a:schemeClr val="tx1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574">
                <a:tc row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i="1" dirty="0" smtClean="0">
                          <a:latin typeface="+mn-lt"/>
                          <a:cs typeface="Courier New" panose="02070309020205020404" pitchFamily="49" charset="0"/>
                        </a:rPr>
                        <a:t>Drooping</a:t>
                      </a:r>
                      <a:r>
                        <a:rPr kumimoji="1" lang="en-US" altLang="ja-JP" sz="1050" i="1" baseline="0" dirty="0" smtClean="0">
                          <a:latin typeface="+mn-lt"/>
                          <a:cs typeface="Courier New" panose="02070309020205020404" pitchFamily="49" charset="0"/>
                        </a:rPr>
                        <a:t> Leaf  </a:t>
                      </a:r>
                      <a:r>
                        <a:rPr kumimoji="1"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(DL)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DL-1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CTTTTGGGTAG</a:t>
                      </a:r>
                      <a:r>
                        <a:rPr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CTGCAG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T /</a:t>
                      </a:r>
                      <a:r>
                        <a:rPr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 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GG 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Pst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DL-2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ACTGACCTGAAAC</a:t>
                      </a:r>
                      <a:r>
                        <a:rPr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GGGCCC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A /</a:t>
                      </a:r>
                      <a:r>
                        <a:rPr lang="en-US" altLang="ja-JP" sz="1050" baseline="0" dirty="0" smtClean="0">
                          <a:latin typeface="+mn-lt"/>
                          <a:cs typeface="Courier New" panose="02070309020205020404" pitchFamily="49" charset="0"/>
                        </a:rPr>
                        <a:t>  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AGG 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Apa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DL-3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ACCTTGCACTGA</a:t>
                      </a:r>
                      <a:r>
                        <a:rPr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CTGCAG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 /  AGG 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Pst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DL-4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CTCAAACGCTTGCC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ATGCA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  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T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Nsi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574">
                <a:tc row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i="1" dirty="0" smtClean="0">
                          <a:latin typeface="+mn-lt"/>
                          <a:cs typeface="Courier New" panose="02070309020205020404" pitchFamily="49" charset="0"/>
                        </a:rPr>
                        <a:t>DNA Ligase IV </a:t>
                      </a:r>
                      <a:r>
                        <a:rPr kumimoji="1" lang="en-US" altLang="ja-JP" sz="1050" i="0" dirty="0" smtClean="0">
                          <a:latin typeface="+mn-lt"/>
                          <a:cs typeface="Courier New" panose="02070309020205020404" pitchFamily="49" charset="0"/>
                        </a:rPr>
                        <a:t>(</a:t>
                      </a:r>
                      <a:r>
                        <a:rPr kumimoji="1" lang="en-US" altLang="ja-JP" sz="1050" i="0" dirty="0" err="1" smtClean="0">
                          <a:latin typeface="+mn-lt"/>
                          <a:cs typeface="Courier New" panose="02070309020205020404" pitchFamily="49" charset="0"/>
                        </a:rPr>
                        <a:t>LigIV</a:t>
                      </a:r>
                      <a:r>
                        <a:rPr kumimoji="1" lang="en-US" altLang="ja-JP" sz="1050" i="0" dirty="0" smtClean="0">
                          <a:latin typeface="+mn-lt"/>
                          <a:cs typeface="Courier New" panose="02070309020205020404" pitchFamily="49" charset="0"/>
                        </a:rPr>
                        <a:t>)</a:t>
                      </a:r>
                      <a:endParaRPr kumimoji="1" lang="ja-JP" altLang="en-US" sz="1050" i="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LigIV-1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ATAGATCGTGAAACAGGTCC /  TGG 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× </a:t>
                      </a:r>
                      <a:r>
                        <a:rPr lang="en-US" altLang="ja-JP" sz="1050" dirty="0" smtClean="0"/>
                        <a:t>††</a:t>
                      </a:r>
                      <a:endParaRPr kumimoji="1" lang="ja-JP" altLang="en-US" sz="1050" dirty="0" smtClean="0">
                        <a:solidFill>
                          <a:srgbClr val="FF0000"/>
                        </a:solidFill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LigIV-2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CAGAACTCGCTG</a:t>
                      </a:r>
                      <a:r>
                        <a:rPr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AGGCCT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 /  TGG 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Stu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LigIV-3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TCAGTTACAAG</a:t>
                      </a:r>
                      <a:r>
                        <a:rPr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GACGTC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C /  CGG 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AatI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LigIV-4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CCAATCCTTCAGAA</a:t>
                      </a:r>
                      <a:r>
                        <a:rPr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GTGCAC</a:t>
                      </a:r>
                      <a:r>
                        <a:rPr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  CGG </a:t>
                      </a:r>
                      <a:endParaRPr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ApaL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574">
                <a:tc row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i="1" dirty="0" err="1" smtClean="0">
                          <a:latin typeface="+mn-lt"/>
                          <a:cs typeface="Courier New" panose="02070309020205020404" pitchFamily="49" charset="0"/>
                        </a:rPr>
                        <a:t>Acetolactate</a:t>
                      </a:r>
                      <a:r>
                        <a:rPr kumimoji="1" lang="en-US" altLang="ja-JP" sz="1050" i="1" baseline="0" dirty="0" smtClean="0">
                          <a:latin typeface="+mn-lt"/>
                          <a:cs typeface="Courier New" panose="02070309020205020404" pitchFamily="49" charset="0"/>
                        </a:rPr>
                        <a:t> synthase</a:t>
                      </a:r>
                      <a:r>
                        <a:rPr kumimoji="1" lang="en-US" altLang="ja-JP" sz="1050" i="0" baseline="0" dirty="0" smtClean="0">
                          <a:latin typeface="+mn-lt"/>
                          <a:cs typeface="Courier New" panose="02070309020205020404" pitchFamily="49" charset="0"/>
                        </a:rPr>
                        <a:t> (ALS)</a:t>
                      </a:r>
                      <a:endParaRPr kumimoji="1" lang="ja-JP" altLang="en-US" sz="1050" i="1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ALS-1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TCTTTGTTACACGGA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CTGC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  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AG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Pst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ALS-2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CCAGCTCCTGAATGT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TCATG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  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A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BspH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ALS-3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TTTGGGCTGCCTGCTG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CAGC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 /  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TG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PvuI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/>
                </a:tc>
              </a:tr>
              <a:tr h="229574"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gALS-4</a:t>
                      </a:r>
                      <a:endParaRPr kumimoji="1" lang="ja-JP" altLang="en-US" sz="1050" dirty="0" smtClean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ACAGAAGCACCAG</a:t>
                      </a:r>
                      <a:r>
                        <a:rPr kumimoji="1" lang="en-US" altLang="ja-JP" sz="1050" u="sng" dirty="0" smtClean="0">
                          <a:latin typeface="+mn-lt"/>
                          <a:cs typeface="Courier New" panose="02070309020205020404" pitchFamily="49" charset="0"/>
                        </a:rPr>
                        <a:t>CTGCAG</a:t>
                      </a:r>
                      <a:r>
                        <a:rPr kumimoji="1" lang="en-US" altLang="ja-JP" sz="1050" dirty="0" smtClean="0">
                          <a:latin typeface="+mn-lt"/>
                          <a:cs typeface="Courier New" panose="02070309020205020404" pitchFamily="49" charset="0"/>
                        </a:rPr>
                        <a:t>C /  AGG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err="1" smtClean="0">
                          <a:latin typeface="+mn-lt"/>
                          <a:cs typeface="Courier New" panose="02070309020205020404" pitchFamily="49" charset="0"/>
                        </a:rPr>
                        <a:t>PstI</a:t>
                      </a:r>
                      <a:endParaRPr kumimoji="1" lang="ja-JP" altLang="en-US" sz="1050" dirty="0"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 smtClean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203200" y="1211670"/>
            <a:ext cx="61976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</a:t>
            </a:r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st of target genes, target sequences and restriction enzymes used in CAPS analysis.</a:t>
            </a:r>
          </a:p>
          <a:p>
            <a:endParaRPr lang="en-US" altLang="ja-JP" sz="10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203199" y="6615405"/>
            <a:ext cx="599907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Restriction enzyme recognition sequences are underlined.</a:t>
            </a:r>
            <a:endParaRPr lang="ja-JP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DS-1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the OsPDS-SP2 target locus  (Shan et al., 2013) on the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DS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</a:t>
            </a:r>
            <a:endParaRPr lang="ja-JP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†Mutations detected by </a:t>
            </a:r>
            <a:r>
              <a:rPr lang="en-US" altLang="ja-JP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analysis.</a:t>
            </a:r>
            <a:endParaRPr lang="ja-JP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71966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9673201"/>
              </p:ext>
            </p:extLst>
          </p:nvPr>
        </p:nvGraphicFramePr>
        <p:xfrm>
          <a:off x="432128" y="577705"/>
          <a:ext cx="5958414" cy="80543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7505"/>
                <a:gridCol w="2119256"/>
                <a:gridCol w="2951653"/>
              </a:tblGrid>
              <a:tr h="188599"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Usage</a:t>
                      </a:r>
                      <a:endParaRPr kumimoji="1" lang="ja-JP" altLang="en-US" sz="1050" dirty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aseline="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rimer name</a:t>
                      </a:r>
                      <a:endParaRPr kumimoji="1" lang="en-US" altLang="ja-JP" sz="1050" kern="1200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equence (5’</a:t>
                      </a:r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  <a:sym typeface="Wingdings" panose="05000000000000000000" pitchFamily="2" charset="2"/>
                        </a:rPr>
                        <a:t>3’</a:t>
                      </a:r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)</a:t>
                      </a:r>
                      <a:endParaRPr kumimoji="1" lang="ja-JP" altLang="en-US" sz="1050" dirty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err="1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RNA-</a:t>
                      </a:r>
                      <a:r>
                        <a:rPr kumimoji="1" lang="en-US" altLang="ja-JP" sz="1000" baseline="0" dirty="0" err="1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oligo</a:t>
                      </a: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1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CGTCCAACCCATTCCTCT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1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CAGAGGAATGGGTTGGAC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2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TGCTTTAAACCGATTTCT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2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AAGAAATCGGTTTAAAG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3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u="none" strike="noStrike" dirty="0" smtClean="0"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ACAGTTGTTTGATCAGCACA</a:t>
                      </a:r>
                      <a:endParaRPr lang="en-US" altLang="ja-JP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3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u="none" strike="noStrike" dirty="0" smtClean="0"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TGTGCTGATCAAACAACTGT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4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u="none" strike="noStrike" dirty="0" smtClean="0"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TAAGAAGGATGTAATACGTA</a:t>
                      </a:r>
                      <a:endParaRPr lang="en-US" altLang="ja-JP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PDS-4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u="none" strike="noStrike" dirty="0" smtClean="0"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TACGTATTACATCCTTCTTA</a:t>
                      </a:r>
                      <a:endParaRPr lang="en-US" altLang="ja-JP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1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TCTTTTGGGTAGCTGCAG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1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ACCTGCAGCTACCCAAAA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2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ACTGACCTGAAACGGGCC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2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TGGGCCCGTTTCAGGTCA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3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GACCTTGCACTGACTGCA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3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CCTGCAGTCAGTGCAAGG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4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TCTCAAACGCTTGCCATG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DL-4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TGCATGGCAAGCGTTTGA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1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ATAGATCGTGAAACAGGTC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1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GACCTGTTTCACGATCTA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2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GCAGAACTCGCTGAGGCCT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2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CAGGCCTCAGCGAGTTCT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9452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3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GTCAGTTACAAGGACGTC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3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CGACGTCCTTGTAACTG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4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CCAATCCTTCAGAAGTGC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LigIV-4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TGCACTTCTGAAGGATT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1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TTCTTTGTTACACGGACT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1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CAGTCCGTGTAACAAAGA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2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CCAGCTCCTGAATGTTCAT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2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CATGAACATTCAGGAGCT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3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TTTGGGCTGCCTGCTGCA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3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CTGCAGCAGGCAGCCCAA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4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TTGACAGAAGCACCAGCTGCA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gALS-4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AACGCTGCAGCTGGTGCTTCT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391463" y="120554"/>
            <a:ext cx="59990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</a:t>
            </a:r>
            <a:r>
              <a:rPr lang="en-US" altLang="ja-JP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Resource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st of primers used in this study. </a:t>
            </a:r>
          </a:p>
        </p:txBody>
      </p:sp>
    </p:spTree>
    <p:extLst>
      <p:ext uri="{BB962C8B-B14F-4D97-AF65-F5344CB8AC3E}">
        <p14:creationId xmlns:p14="http://schemas.microsoft.com/office/powerpoint/2010/main" val="11656664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8363721"/>
              </p:ext>
            </p:extLst>
          </p:nvPr>
        </p:nvGraphicFramePr>
        <p:xfrm>
          <a:off x="432128" y="301694"/>
          <a:ext cx="5958414" cy="36804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7505"/>
                <a:gridCol w="2119256"/>
                <a:gridCol w="2951653"/>
              </a:tblGrid>
              <a:tr h="188599"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Usage</a:t>
                      </a:r>
                      <a:endParaRPr kumimoji="1" lang="ja-JP" altLang="en-US" sz="1050" dirty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aseline="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rimer name</a:t>
                      </a:r>
                      <a:endParaRPr kumimoji="1" lang="en-US" altLang="ja-JP" sz="1050" kern="1200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equence (5’</a:t>
                      </a:r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  <a:sym typeface="Wingdings" panose="05000000000000000000" pitchFamily="2" charset="2"/>
                        </a:rPr>
                        <a:t>3’</a:t>
                      </a:r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)</a:t>
                      </a:r>
                      <a:endParaRPr kumimoji="1" lang="ja-JP" altLang="en-US" sz="1050" dirty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99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 smtClean="0"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CAPS PCR</a:t>
                      </a:r>
                      <a:endParaRPr kumimoji="1" lang="ja-JP" altLang="en-US" sz="105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YSA-F</a:t>
                      </a:r>
                      <a:endParaRPr kumimoji="1" lang="en-US" altLang="ja-JP" sz="1000" kern="1200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CATGCGCTCTCTTCCCCACCTGTACTT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99">
                <a:tc>
                  <a:txBody>
                    <a:bodyPr/>
                    <a:lstStyle/>
                    <a:p>
                      <a:endParaRPr kumimoji="1" lang="ja-JP" altLang="en-US" sz="1050" dirty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YSA-R</a:t>
                      </a:r>
                      <a:endParaRPr kumimoji="1" lang="en-US" altLang="ja-JP" sz="1000" kern="1200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CCCTAGCACCCATCTCCGAGTACACTGATT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DS-1F </a:t>
                      </a:r>
                      <a:endParaRPr lang="ja-JP" altLang="en-US" sz="1000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TGCAAGGTACTAACTAGGAGACAT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DS-1R</a:t>
                      </a:r>
                      <a:endParaRPr kumimoji="1" lang="en-US" altLang="ja-JP" sz="1000" u="none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TTGTAAACAGATCTGTAACAGTGA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DS-2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TCACATTGGGAAGAACTGGCAG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DS-2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AAGAGCGAACATGGTCAACAATAGGCATG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L-1F 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CAGTGTCATGTTCCATCTTTCGCTTCC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L-1R </a:t>
                      </a:r>
                      <a:endParaRPr kumimoji="1" lang="en-US" altLang="ja-JP" sz="1000" u="none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ATGGGCAAGAGAGAAATCTTTTGCAATCC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L-2F</a:t>
                      </a:r>
                      <a:endParaRPr kumimoji="1" lang="en-US" altLang="ja-JP" sz="1000" u="none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TGCAAAAGATTTCTCTCTTGCCCATCTGT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L-2R</a:t>
                      </a:r>
                      <a:endParaRPr kumimoji="1" lang="en-US" altLang="ja-JP" sz="1000" u="none" dirty="0" smtClean="0">
                        <a:solidFill>
                          <a:schemeClr val="tx1"/>
                        </a:solidFill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TTTCTCACCTCATGAAGCGGTTGTAAGCA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err="1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LigIV</a:t>
                      </a:r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TGACAAGCTTGAGGAAAATGAGAAGGCTG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err="1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LigIV</a:t>
                      </a:r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ATGGCAACCTACTCCTCTCACAACACAAC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LS-F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AATTATGCCGTGGATAAGGCTGACCTGTT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973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u="none" dirty="0" smtClean="0"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u="none" dirty="0" smtClean="0">
                          <a:solidFill>
                            <a:schemeClr val="tx1"/>
                          </a:solidFill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LS-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 ACCCAATAAGATCGACCGAAGAGAGGGAA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2386140"/>
              </p:ext>
            </p:extLst>
          </p:nvPr>
        </p:nvGraphicFramePr>
        <p:xfrm>
          <a:off x="432128" y="19050"/>
          <a:ext cx="5070909" cy="243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19256"/>
                <a:gridCol w="2951653"/>
              </a:tblGrid>
              <a:tr h="229736"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continued</a:t>
                      </a:r>
                      <a:endParaRPr kumimoji="1" lang="en-US" altLang="ja-JP" sz="1000" u="none" dirty="0" smtClean="0">
                        <a:solidFill>
                          <a:schemeClr val="tx1"/>
                        </a:solidFill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713805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5734930"/>
              </p:ext>
            </p:extLst>
          </p:nvPr>
        </p:nvGraphicFramePr>
        <p:xfrm>
          <a:off x="629752" y="3761375"/>
          <a:ext cx="5208472" cy="951781"/>
        </p:xfrm>
        <a:graphic>
          <a:graphicData uri="http://schemas.openxmlformats.org/drawingml/2006/table">
            <a:tbl>
              <a:tblPr/>
              <a:tblGrid>
                <a:gridCol w="623549"/>
                <a:gridCol w="654989"/>
                <a:gridCol w="654989"/>
                <a:gridCol w="654989"/>
                <a:gridCol w="654989"/>
                <a:gridCol w="654989"/>
                <a:gridCol w="654989"/>
                <a:gridCol w="654989"/>
              </a:tblGrid>
              <a:tr h="3958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rget ge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tation</a:t>
                      </a:r>
                      <a:r>
                        <a:rPr lang="en-US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frequency in transgenic callus (%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. of T0 regenerated</a:t>
                      </a:r>
                      <a:r>
                        <a:rPr lang="en-US" altLang="ja-JP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altLang="ja-JP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nts</a:t>
                      </a:r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No. of mono-allelic</a:t>
                      </a:r>
                      <a:r>
                        <a:rPr lang="en-US" altLang="ja-JP" sz="9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mutants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Ratio of mono-allelic mutants (%)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o. of bi-allelic</a:t>
                      </a:r>
                      <a:r>
                        <a:rPr lang="en-US" altLang="ja-JP" sz="9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mutants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atio of bi-allelic mutants (%)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Ratio of mutated plants (%)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58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S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</a:t>
                      </a: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7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79" marR="7279" marT="72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正方形/長方形 8"/>
          <p:cNvSpPr/>
          <p:nvPr/>
        </p:nvSpPr>
        <p:spPr>
          <a:xfrm>
            <a:off x="505574" y="2896836"/>
            <a:ext cx="599907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3</a:t>
            </a:r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ion frequency  in pZH_MMOsCas9 and pZK_OsU3-gYSA transformed callus and ratio of mutated regenerated plants.</a:t>
            </a:r>
          </a:p>
        </p:txBody>
      </p:sp>
    </p:spTree>
    <p:extLst>
      <p:ext uri="{BB962C8B-B14F-4D97-AF65-F5344CB8AC3E}">
        <p14:creationId xmlns:p14="http://schemas.microsoft.com/office/powerpoint/2010/main" val="1463277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C:\Users\genome\Desktop\図25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0966" y="633403"/>
            <a:ext cx="3877056" cy="1269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Users\genome\Desktop\図24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670" y="651742"/>
            <a:ext cx="3915030" cy="12607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テキスト ボックス 50"/>
          <p:cNvSpPr txBox="1"/>
          <p:nvPr/>
        </p:nvSpPr>
        <p:spPr>
          <a:xfrm>
            <a:off x="402541" y="387182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90088" y="3460323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Arial"/>
              </a:rPr>
              <a:t>(</a:t>
            </a:r>
            <a:r>
              <a:rPr lang="en-US" altLang="ja-JP" sz="1000" b="1" dirty="0">
                <a:latin typeface="Arial"/>
              </a:rPr>
              <a:t>B</a:t>
            </a:r>
            <a:r>
              <a:rPr kumimoji="1" lang="en-US" altLang="ja-JP" sz="1000" b="1" dirty="0" smtClean="0">
                <a:latin typeface="Arial"/>
              </a:rPr>
              <a:t>)</a:t>
            </a:r>
            <a:endParaRPr kumimoji="1" lang="ja-JP" altLang="en-US" sz="1000" b="1" dirty="0">
              <a:latin typeface="Arial"/>
            </a:endParaRPr>
          </a:p>
        </p:txBody>
      </p:sp>
      <p:sp>
        <p:nvSpPr>
          <p:cNvPr id="55" name="正方形/長方形 54"/>
          <p:cNvSpPr/>
          <p:nvPr/>
        </p:nvSpPr>
        <p:spPr>
          <a:xfrm>
            <a:off x="210052" y="7215881"/>
            <a:ext cx="652182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4.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-efficiency targeted mutagenesis using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ZH_OsU6gRNA_MMCas9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 in rice DL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.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 analysis of the gDL-1, gDL-2 and gDL-4 loci. DNAs extracted from independent transformed 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li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as9/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NA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-in-one vector were subjected to PCR and subsequent restriction enzyme digestion. WT, non-transgenic callus lines. Mutation frequencies in line #1 (yellow dashed square) are shown below. </a:t>
            </a:r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tions detected by sequencing analysis. The wild type sequence is shown at the top with the PAM sequence highlighted in green, the 20 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rget sequence in red. The blue arrowhead indicates the expected cleavage site. Dash, deleted bases. The net change in length is shown to the right of each sequence (+, insertion; – deletion). </a:t>
            </a:r>
            <a:endParaRPr lang="ja-JP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4" descr="C:\Users\genome\Desktop\図26.ti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951" y="1912514"/>
            <a:ext cx="3744468" cy="1260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5" descr="C:\Users\genome\Desktop\図27.tif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290" y="3867150"/>
            <a:ext cx="5737487" cy="31518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2050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987276" y="6469114"/>
            <a:ext cx="503187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5</a:t>
            </a:r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tions detected in regenerated plants obtained from pZH_OsU6gRNA_MMCas9 transformed 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li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generated plants representing each mutant allele is shown in brackets. (b), bi-allelic mutant plants with same mutation.</a:t>
            </a:r>
            <a:endParaRPr lang="ja-JP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 descr="C:\Users\genome\Desktop\図5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9041" y="2438411"/>
            <a:ext cx="4588342" cy="37705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3705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332095"/>
              </p:ext>
            </p:extLst>
          </p:nvPr>
        </p:nvGraphicFramePr>
        <p:xfrm>
          <a:off x="658521" y="2551408"/>
          <a:ext cx="2104850" cy="924695"/>
        </p:xfrm>
        <a:graphic>
          <a:graphicData uri="http://schemas.openxmlformats.org/drawingml/2006/table">
            <a:tbl>
              <a:tblPr/>
              <a:tblGrid>
                <a:gridCol w="1304750"/>
                <a:gridCol w="266700"/>
                <a:gridCol w="266700"/>
                <a:gridCol w="266700"/>
              </a:tblGrid>
              <a:tr h="11702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allus No.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#3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0255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Regenerated plants 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2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3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gDL-1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Mutations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A)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26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T)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T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henotype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*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9709483"/>
              </p:ext>
            </p:extLst>
          </p:nvPr>
        </p:nvGraphicFramePr>
        <p:xfrm>
          <a:off x="657908" y="3665465"/>
          <a:ext cx="4855390" cy="924695"/>
        </p:xfrm>
        <a:graphic>
          <a:graphicData uri="http://schemas.openxmlformats.org/drawingml/2006/table">
            <a:tbl>
              <a:tblPr/>
              <a:tblGrid>
                <a:gridCol w="1297823"/>
                <a:gridCol w="273659"/>
                <a:gridCol w="273659"/>
                <a:gridCol w="273659"/>
                <a:gridCol w="273659"/>
                <a:gridCol w="273659"/>
                <a:gridCol w="273659"/>
                <a:gridCol w="273659"/>
                <a:gridCol w="273659"/>
                <a:gridCol w="273659"/>
                <a:gridCol w="273659"/>
                <a:gridCol w="273659"/>
                <a:gridCol w="273659"/>
                <a:gridCol w="273659"/>
              </a:tblGrid>
              <a:tr h="1018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allus No.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#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#2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1681"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Regenerated plants </a:t>
                      </a:r>
                      <a:endParaRPr kumimoji="1" lang="en-US" altLang="ja-JP" sz="1050" b="0" i="0" u="none" strike="noStrike" kern="1200" dirty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2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3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4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5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6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7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8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2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3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4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5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07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gDL-2</a:t>
                      </a:r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　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M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M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</a:tr>
              <a:tr h="507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Mutations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T,T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T,C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T,C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T,T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29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T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577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7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T,C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T,T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T,T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</a:tr>
              <a:tr h="50720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Phenotype</a:t>
                      </a:r>
                      <a:endParaRPr kumimoji="1" lang="ja-JP" altLang="en-US" sz="105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0545776"/>
              </p:ext>
            </p:extLst>
          </p:nvPr>
        </p:nvGraphicFramePr>
        <p:xfrm>
          <a:off x="657908" y="5885769"/>
          <a:ext cx="4606620" cy="924695"/>
        </p:xfrm>
        <a:graphic>
          <a:graphicData uri="http://schemas.openxmlformats.org/drawingml/2006/table">
            <a:tbl>
              <a:tblPr/>
              <a:tblGrid>
                <a:gridCol w="1309896"/>
                <a:gridCol w="274727"/>
                <a:gridCol w="274727"/>
                <a:gridCol w="274727"/>
                <a:gridCol w="274727"/>
                <a:gridCol w="274727"/>
                <a:gridCol w="274727"/>
                <a:gridCol w="274727"/>
                <a:gridCol w="274727"/>
                <a:gridCol w="274727"/>
                <a:gridCol w="274727"/>
                <a:gridCol w="274727"/>
                <a:gridCol w="274727"/>
              </a:tblGrid>
              <a:tr h="49425"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callus</a:t>
                      </a:r>
                      <a:r>
                        <a:rPr kumimoji="1" lang="en-US" altLang="ja-JP" sz="1050" b="0" i="0" u="none" strike="noStrike" kern="1200" baseline="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 No.</a:t>
                      </a:r>
                      <a:endParaRPr kumimoji="1" lang="en-US" altLang="ja-JP" sz="1050" b="0" i="0" u="none" strike="noStrike" kern="1200" dirty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#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#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2550"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Regenerated plants </a:t>
                      </a:r>
                      <a:endParaRPr kumimoji="1" lang="en-US" altLang="ja-JP" sz="1050" b="0" i="0" u="none" strike="noStrike" kern="1200" dirty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2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3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4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5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6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7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2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3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4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5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213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gDL-4</a:t>
                      </a:r>
                      <a:r>
                        <a:rPr lang="en-US" altLang="ja-JP" sz="1050" dirty="0" smtClean="0"/>
                        <a:t>†</a:t>
                      </a:r>
                      <a:endParaRPr kumimoji="1" lang="ja-JP" altLang="en-US" sz="105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M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M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</a:tr>
              <a:tr h="48213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Mutations</a:t>
                      </a:r>
                      <a:endParaRPr kumimoji="1" lang="ja-JP" altLang="en-US" sz="105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11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1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1" lang="en-US" altLang="ja-JP" sz="8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kumimoji="1" lang="en-US" altLang="ja-JP" sz="8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A,A)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2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2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2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A,A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Phenotype</a:t>
                      </a:r>
                      <a:endParaRPr kumimoji="1" lang="ja-JP" altLang="en-US" sz="105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3753353" y="6885508"/>
            <a:ext cx="20233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i-allelic mutation</a:t>
            </a:r>
          </a:p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ono-allelic mutation </a:t>
            </a:r>
          </a:p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,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on-mutation</a:t>
            </a:r>
          </a:p>
          <a:p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, drooping leaf</a:t>
            </a:r>
          </a:p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, wild typ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408518" y="1897601"/>
            <a:ext cx="550650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</a:t>
            </a:r>
            <a:r>
              <a:rPr lang="en-US" altLang="ja-JP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Resource </a:t>
            </a:r>
            <a:r>
              <a:rPr lang="en-US" altLang="ja-JP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ions  in DL gene in regenerated plants obtained from transformed </a:t>
            </a:r>
            <a:r>
              <a:rPr lang="en-US" altLang="ja-JP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li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of pZH_OsU6gRNA_MMCas9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ch target gDL-1, 2, 3 or 4.</a:t>
            </a:r>
          </a:p>
        </p:txBody>
      </p:sp>
      <p:sp>
        <p:nvSpPr>
          <p:cNvPr id="13" name="正方形/長方形 12"/>
          <p:cNvSpPr/>
          <p:nvPr/>
        </p:nvSpPr>
        <p:spPr>
          <a:xfrm>
            <a:off x="657907" y="6860672"/>
            <a:ext cx="291079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bi-allelic mutant plant with 3-nt deletion.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altLang="ja-JP" sz="1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eavage site of gDL-4 exists in intron.</a:t>
            </a:r>
          </a:p>
        </p:txBody>
      </p:sp>
      <p:graphicFrame>
        <p:nvGraphicFramePr>
          <p:cNvPr id="14" name="表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3998263"/>
              </p:ext>
            </p:extLst>
          </p:nvPr>
        </p:nvGraphicFramePr>
        <p:xfrm>
          <a:off x="657907" y="4693023"/>
          <a:ext cx="3779625" cy="924695"/>
        </p:xfrm>
        <a:graphic>
          <a:graphicData uri="http://schemas.openxmlformats.org/drawingml/2006/table">
            <a:tbl>
              <a:tblPr/>
              <a:tblGrid>
                <a:gridCol w="1306415"/>
                <a:gridCol w="247321"/>
                <a:gridCol w="247321"/>
                <a:gridCol w="247321"/>
                <a:gridCol w="247321"/>
                <a:gridCol w="247321"/>
                <a:gridCol w="247321"/>
                <a:gridCol w="247321"/>
                <a:gridCol w="247321"/>
                <a:gridCol w="247321"/>
                <a:gridCol w="247321"/>
              </a:tblGrid>
              <a:tr h="122388"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Callus</a:t>
                      </a:r>
                      <a:r>
                        <a:rPr kumimoji="1" lang="en-US" altLang="ja-JP" sz="1050" b="0" i="0" u="none" strike="noStrike" kern="1200" baseline="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 No.</a:t>
                      </a:r>
                      <a:endParaRPr kumimoji="1" lang="en-US" altLang="ja-JP" sz="1050" b="0" i="0" u="none" strike="noStrike" kern="1200" dirty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#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55" marR="8155" marT="8155" marB="0" anchor="ctr">
                    <a:lnL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46AAC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BACC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2550"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Regenerated plants </a:t>
                      </a:r>
                      <a:endParaRPr kumimoji="1" lang="en-US" altLang="ja-JP" sz="1050" b="0" i="0" u="none" strike="noStrike" kern="1200" dirty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2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3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4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5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6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7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8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9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213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gDL-3</a:t>
                      </a:r>
                      <a:endParaRPr kumimoji="1" lang="ja-JP" altLang="en-US" sz="105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N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M</a:t>
                      </a: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48213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Mutations</a:t>
                      </a:r>
                      <a:endParaRPr kumimoji="1" lang="ja-JP" altLang="en-US" sz="105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1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3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C,C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C,C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10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T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3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3,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-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</a:t>
                      </a:r>
                    </a:p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(C,C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+1(C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Phenotype</a:t>
                      </a:r>
                      <a:endParaRPr kumimoji="1" lang="ja-JP" altLang="en-US" sz="105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*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*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*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D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W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155" marR="8155" marT="815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84114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84</TotalTime>
  <Words>953</Words>
  <Application>Microsoft Office PowerPoint</Application>
  <PresentationFormat>画面に合わせる (4:3)</PresentationFormat>
  <Paragraphs>408</Paragraphs>
  <Slides>7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8" baseType="lpstr"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NI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saki Endo</dc:creator>
  <cp:lastModifiedBy>Mikami　Masafumi</cp:lastModifiedBy>
  <cp:revision>693</cp:revision>
  <cp:lastPrinted>2014-11-10T10:25:58Z</cp:lastPrinted>
  <dcterms:created xsi:type="dcterms:W3CDTF">2014-11-08T01:49:18Z</dcterms:created>
  <dcterms:modified xsi:type="dcterms:W3CDTF">2015-05-24T06:56:31Z</dcterms:modified>
</cp:coreProperties>
</file>